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-153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A64B-D4E3-477C-A78E-E05BF6FE3AAC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1E0E4-A632-4D7F-878F-1A3FFA132B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072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A64B-D4E3-477C-A78E-E05BF6FE3AAC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1E0E4-A632-4D7F-878F-1A3FFA132B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121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A64B-D4E3-477C-A78E-E05BF6FE3AAC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1E0E4-A632-4D7F-878F-1A3FFA132B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626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A64B-D4E3-477C-A78E-E05BF6FE3AAC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1E0E4-A632-4D7F-878F-1A3FFA132B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106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A64B-D4E3-477C-A78E-E05BF6FE3AAC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1E0E4-A632-4D7F-878F-1A3FFA132B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2722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A64B-D4E3-477C-A78E-E05BF6FE3AAC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1E0E4-A632-4D7F-878F-1A3FFA132B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547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A64B-D4E3-477C-A78E-E05BF6FE3AAC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1E0E4-A632-4D7F-878F-1A3FFA132B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608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A64B-D4E3-477C-A78E-E05BF6FE3AAC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1E0E4-A632-4D7F-878F-1A3FFA132B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85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A64B-D4E3-477C-A78E-E05BF6FE3AAC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1E0E4-A632-4D7F-878F-1A3FFA132B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510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A64B-D4E3-477C-A78E-E05BF6FE3AAC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1E0E4-A632-4D7F-878F-1A3FFA132B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1154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A64B-D4E3-477C-A78E-E05BF6FE3AAC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1E0E4-A632-4D7F-878F-1A3FFA132B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933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0A64B-D4E3-477C-A78E-E05BF6FE3AAC}" type="datetimeFigureOut">
              <a:rPr lang="en-US" smtClean="0"/>
              <a:t>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C1E0E4-A632-4D7F-878F-1A3FFA132B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364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1064654"/>
            <a:ext cx="3276600" cy="32766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4800" y="1066800"/>
            <a:ext cx="3352800" cy="33528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85800" y="92606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419600" y="9144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723362" y="4572000"/>
            <a:ext cx="727763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2: ROC curve for predicting SVR for PR (A) and T/PR (B) subjects using only the five identified peptides as predictors.  The model was fitted using only data from the PR subjects and is independently validated on the T/PR subjects.  AUCs for A and B are 0.97 and 0.81, respectively</a:t>
            </a:r>
            <a:r>
              <a:rPr lang="en-US" b="1" dirty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6102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2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ertex Pharmaceuticals Incorporate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Administrator</cp:lastModifiedBy>
  <cp:revision>2</cp:revision>
  <dcterms:created xsi:type="dcterms:W3CDTF">2015-01-11T19:36:50Z</dcterms:created>
  <dcterms:modified xsi:type="dcterms:W3CDTF">2015-01-11T19:45:29Z</dcterms:modified>
</cp:coreProperties>
</file>